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3380" autoAdjust="0"/>
    <p:restoredTop sz="94660"/>
  </p:normalViewPr>
  <p:slideViewPr>
    <p:cSldViewPr snapToGrid="0">
      <p:cViewPr>
        <p:scale>
          <a:sx n="50" d="100"/>
          <a:sy n="50" d="100"/>
        </p:scale>
        <p:origin x="3630" y="5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8779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34149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4992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6638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3104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4692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8563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46164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1039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8040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3765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30214E5-2012-4D29-950B-211BA66501A5}" type="datetimeFigureOut">
              <a:rPr lang="ko-KR" altLang="en-US" smtClean="0"/>
              <a:t>2025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645B2A0-16FE-4107-A1F3-570BEAD9F2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7802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그룹 6">
            <a:extLst>
              <a:ext uri="{FF2B5EF4-FFF2-40B4-BE49-F238E27FC236}">
                <a16:creationId xmlns:a16="http://schemas.microsoft.com/office/drawing/2014/main" id="{D5F88E0E-F590-6DF9-8B76-5161F2D3B593}"/>
              </a:ext>
            </a:extLst>
          </p:cNvPr>
          <p:cNvGrpSpPr/>
          <p:nvPr/>
        </p:nvGrpSpPr>
        <p:grpSpPr>
          <a:xfrm>
            <a:off x="247650" y="3346221"/>
            <a:ext cx="6362700" cy="5499557"/>
            <a:chOff x="209550" y="3505200"/>
            <a:chExt cx="6362700" cy="5499557"/>
          </a:xfrm>
        </p:grpSpPr>
        <p:pic>
          <p:nvPicPr>
            <p:cNvPr id="4" name="그림 3" descr="의료 영상, 엑스레이 필름이(가) 표시된 사진&#10;&#10;자동 생성된 설명">
              <a:extLst>
                <a:ext uri="{FF2B5EF4-FFF2-40B4-BE49-F238E27FC236}">
                  <a16:creationId xmlns:a16="http://schemas.microsoft.com/office/drawing/2014/main" id="{49F43812-6912-AE76-B6E0-0644246BCDE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3703" y="3505200"/>
              <a:ext cx="5970593" cy="32004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F355B9A0-9817-335B-2454-5E4092D0C6CD}"/>
                </a:ext>
              </a:extLst>
            </p:cNvPr>
            <p:cNvSpPr txBox="1"/>
            <p:nvPr/>
          </p:nvSpPr>
          <p:spPr>
            <a:xfrm>
              <a:off x="209550" y="7927539"/>
              <a:ext cx="6362700" cy="107721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1600" b="1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Supplementary Figure S1. </a:t>
              </a:r>
              <a:r>
                <a:rPr lang="en-US" altLang="ko-KR" sz="16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Preparation of mouse brain tissues for immunoreactivity. From </a:t>
              </a:r>
              <a:r>
                <a:rPr lang="ko-KR" altLang="ko-KR" sz="16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①</a:t>
              </a:r>
              <a:r>
                <a:rPr lang="en-US" altLang="ko-KR" sz="16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 to </a:t>
              </a:r>
              <a:r>
                <a:rPr lang="ko-KR" altLang="ko-KR" sz="16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②</a:t>
              </a:r>
              <a:r>
                <a:rPr lang="en-US" altLang="ko-KR" sz="1600" dirty="0">
                  <a:effectLst/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, frontal cortex was designated between 1.42 to 2.22 mm from bregma. The acquired images were subjected to topographical quantification and statistical analysis in a blind manner.  </a:t>
              </a:r>
              <a:endParaRPr lang="ko-KR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95408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4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[대학원생]이영채</dc:creator>
  <cp:lastModifiedBy>MDPI</cp:lastModifiedBy>
  <cp:revision>3</cp:revision>
  <dcterms:created xsi:type="dcterms:W3CDTF">2024-09-25T08:34:22Z</dcterms:created>
  <dcterms:modified xsi:type="dcterms:W3CDTF">2025-12-27T08:50:40Z</dcterms:modified>
</cp:coreProperties>
</file>